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06520" y="720360"/>
            <a:ext cx="2702160" cy="360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2024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AAE4BD-4A95-4240-9CAB-D15AB16AA3D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Rectangle 7"/>
          <p:cNvSpPr/>
          <p:nvPr/>
        </p:nvSpPr>
        <p:spPr>
          <a:xfrm>
            <a:off x="414324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DF0699-5B0B-4F45-A0D8-D2CF46D0393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2306520" y="720720"/>
            <a:ext cx="2702160" cy="360036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219AB-1EA9-44E3-B580-ECC4E4C5E5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D7C113-67BD-4A01-A23E-8509D0640D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99B8E0-9CD1-4E71-8099-7239E23A23D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0481DA-48E2-4BF2-8490-4C084A6616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364663-134A-42D3-A312-B3C37675CE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6D6116-11E1-41FF-AD64-C473A625B1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A47FDE-4842-4E97-8E27-235CD3004D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B25A53-68D2-4711-AB35-5D60FF00EC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2146D-18B9-454A-8CF0-8AD441B056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BAD9A-B86F-447B-8B79-F90C03479F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49EB7E-F93E-494A-B0AF-0F0A69221A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A7FD8A-48DC-40A3-9CFE-8ED16218FA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F74A94-3408-4A68-ACED-7A4FC89A814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slideLayout" Target="../slideLayouts/slideLayout1.xml"/><Relationship Id="rId1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2"/>
          <p:cNvSpPr/>
          <p:nvPr/>
        </p:nvSpPr>
        <p:spPr>
          <a:xfrm>
            <a:off x="5345280" y="477720"/>
            <a:ext cx="1130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erfect Matc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00% Identity and coverag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3"/>
          <p:cNvSpPr/>
          <p:nvPr/>
        </p:nvSpPr>
        <p:spPr>
          <a:xfrm>
            <a:off x="4800600" y="2149560"/>
            <a:ext cx="209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Highly conserve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&gt;97% identity and coverag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4"/>
          <p:cNvSpPr/>
          <p:nvPr/>
        </p:nvSpPr>
        <p:spPr>
          <a:xfrm>
            <a:off x="5285520" y="6959520"/>
            <a:ext cx="1434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o matc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&lt;75% identity and/or &lt;70% coverag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8" descr=""/>
          <p:cNvPicPr/>
          <p:nvPr/>
        </p:nvPicPr>
        <p:blipFill>
          <a:blip r:embed="rId1"/>
          <a:stretch/>
        </p:blipFill>
        <p:spPr>
          <a:xfrm>
            <a:off x="0" y="380880"/>
            <a:ext cx="2286000" cy="18939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9" descr=""/>
          <p:cNvPicPr/>
          <p:nvPr/>
        </p:nvPicPr>
        <p:blipFill>
          <a:blip r:embed="rId2"/>
          <a:stretch/>
        </p:blipFill>
        <p:spPr>
          <a:xfrm>
            <a:off x="2390760" y="92160"/>
            <a:ext cx="1152720" cy="15080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0" descr=""/>
          <p:cNvPicPr/>
          <p:nvPr/>
        </p:nvPicPr>
        <p:blipFill>
          <a:blip r:embed="rId3"/>
          <a:stretch/>
        </p:blipFill>
        <p:spPr>
          <a:xfrm>
            <a:off x="2309760" y="1623960"/>
            <a:ext cx="1233720" cy="157644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1" descr=""/>
          <p:cNvPicPr/>
          <p:nvPr/>
        </p:nvPicPr>
        <p:blipFill>
          <a:blip r:embed="rId4"/>
          <a:stretch/>
        </p:blipFill>
        <p:spPr>
          <a:xfrm>
            <a:off x="2247840" y="3124080"/>
            <a:ext cx="1301760" cy="171288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12" descr=""/>
          <p:cNvPicPr/>
          <p:nvPr/>
        </p:nvPicPr>
        <p:blipFill>
          <a:blip r:embed="rId5"/>
          <a:stretch/>
        </p:blipFill>
        <p:spPr>
          <a:xfrm>
            <a:off x="2309760" y="4724280"/>
            <a:ext cx="1233720" cy="171288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13" descr=""/>
          <p:cNvPicPr/>
          <p:nvPr/>
        </p:nvPicPr>
        <p:blipFill>
          <a:blip r:embed="rId6"/>
          <a:stretch/>
        </p:blipFill>
        <p:spPr>
          <a:xfrm>
            <a:off x="2241720" y="6400800"/>
            <a:ext cx="1301760" cy="17524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14" descr=""/>
          <p:cNvPicPr/>
          <p:nvPr/>
        </p:nvPicPr>
        <p:blipFill>
          <a:blip r:embed="rId7"/>
          <a:srcRect l="0" t="0" r="0" b="10367"/>
          <a:stretch/>
        </p:blipFill>
        <p:spPr>
          <a:xfrm>
            <a:off x="3695760" y="6400800"/>
            <a:ext cx="1676520" cy="152388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15" descr=""/>
          <p:cNvPicPr/>
          <p:nvPr/>
        </p:nvPicPr>
        <p:blipFill>
          <a:blip r:embed="rId8"/>
          <a:srcRect l="0" t="0" r="0" b="9272"/>
          <a:stretch/>
        </p:blipFill>
        <p:spPr>
          <a:xfrm>
            <a:off x="3695760" y="4818240"/>
            <a:ext cx="1676520" cy="146664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16" descr=""/>
          <p:cNvPicPr/>
          <p:nvPr/>
        </p:nvPicPr>
        <p:blipFill>
          <a:blip r:embed="rId9"/>
          <a:srcRect l="0" t="0" r="0" b="8309"/>
          <a:stretch/>
        </p:blipFill>
        <p:spPr>
          <a:xfrm>
            <a:off x="3695760" y="3200400"/>
            <a:ext cx="1676520" cy="148428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17" descr=""/>
          <p:cNvPicPr/>
          <p:nvPr/>
        </p:nvPicPr>
        <p:blipFill>
          <a:blip r:embed="rId10"/>
          <a:srcRect l="0" t="0" r="0" b="11427"/>
          <a:stretch/>
        </p:blipFill>
        <p:spPr>
          <a:xfrm>
            <a:off x="3652920" y="1600200"/>
            <a:ext cx="1719360" cy="146988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18" descr=""/>
          <p:cNvPicPr/>
          <p:nvPr/>
        </p:nvPicPr>
        <p:blipFill>
          <a:blip r:embed="rId11"/>
          <a:srcRect l="0" t="0" r="0" b="9355"/>
          <a:stretch/>
        </p:blipFill>
        <p:spPr>
          <a:xfrm>
            <a:off x="3619440" y="0"/>
            <a:ext cx="1752840" cy="1533600"/>
          </a:xfrm>
          <a:prstGeom prst="rect">
            <a:avLst/>
          </a:prstGeom>
          <a:ln w="0">
            <a:noFill/>
          </a:ln>
        </p:spPr>
      </p:pic>
      <p:sp>
        <p:nvSpPr>
          <p:cNvPr id="62" name="Rectangle 19"/>
          <p:cNvSpPr/>
          <p:nvPr/>
        </p:nvSpPr>
        <p:spPr>
          <a:xfrm>
            <a:off x="4078080" y="4585680"/>
            <a:ext cx="109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log2(B)+log2(M))/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20"/>
          <p:cNvSpPr/>
          <p:nvPr/>
        </p:nvSpPr>
        <p:spPr>
          <a:xfrm>
            <a:off x="4048200" y="3047400"/>
            <a:ext cx="109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log2(B)+log2(M))/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21"/>
          <p:cNvSpPr/>
          <p:nvPr/>
        </p:nvSpPr>
        <p:spPr>
          <a:xfrm>
            <a:off x="4124160" y="7862400"/>
            <a:ext cx="109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log2(B)+log2(M))/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22"/>
          <p:cNvSpPr/>
          <p:nvPr/>
        </p:nvSpPr>
        <p:spPr>
          <a:xfrm>
            <a:off x="4093920" y="6208200"/>
            <a:ext cx="109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log2(B)+log2(M))/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23"/>
          <p:cNvSpPr/>
          <p:nvPr/>
        </p:nvSpPr>
        <p:spPr>
          <a:xfrm>
            <a:off x="4048200" y="1447200"/>
            <a:ext cx="109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log2(B)+log2(M))/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24"/>
          <p:cNvSpPr/>
          <p:nvPr/>
        </p:nvSpPr>
        <p:spPr>
          <a:xfrm>
            <a:off x="4800600" y="3902040"/>
            <a:ext cx="209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nserve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&gt;90% identity and coverag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25"/>
          <p:cNvSpPr/>
          <p:nvPr/>
        </p:nvSpPr>
        <p:spPr>
          <a:xfrm>
            <a:off x="4800600" y="5334120"/>
            <a:ext cx="2438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oorly conserve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&gt;75% identity and &gt; 70%coverag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2T21:23:30Z</dcterms:created>
  <dc:creator>Nathan Springer</dc:creator>
  <dc:description/>
  <dc:language>en-US</dc:language>
  <cp:lastModifiedBy>acollings</cp:lastModifiedBy>
  <dcterms:modified xsi:type="dcterms:W3CDTF">2009-11-13T11:19:46Z</dcterms:modified>
  <cp:revision>28</cp:revision>
  <dc:subject/>
  <dc:title>Slide 1</dc:title>
</cp:coreProperties>
</file>